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792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C7ABFA-24C6-FCCB-A42C-88C36E90C4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969B435-F82A-8555-64F7-1012FD696F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68BB38-352B-3B97-FBB5-D24073FC3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AE53DD-C326-7743-3C08-E09B21457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B9CA79-B6BC-B72B-3BC5-786FE5960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423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021DC3-99FB-427A-D480-211C8615B0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20BD73D-A5AC-4AA0-D605-F8668FB4C2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B911B0-EE3F-C02F-52CF-2900A3F2E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520E0AB-7827-4E19-B0E8-D8CB7EAC0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5E5FA7-43FE-56F6-B898-E52CA9F1E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1835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69B9FCF-98B1-3312-0651-F38FA49FAB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46FC5AE-DE63-AE1E-1F63-5E39E29845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8EC80B-38F9-3D3A-5020-A4E78AD09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B5B125-BC1D-FD8A-68FE-F2436BA0E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388043-BB15-9667-E51E-CF2B80C07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043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410B69-2652-46DA-7554-493131BDE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172BAE7-C32B-4434-5EAF-0EF6E175D3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E36C95-FEAD-E3E9-94B2-F68D50372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3A4CB6D-68F3-B542-2B0E-7ED907A14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1870FA-30B5-C041-2370-ED15B842A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4300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9F782E-E91D-E3FD-A265-CD7AAF8CCB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1213688-03D6-7F8D-3229-136B2727D1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C8BDFF-990B-0CED-CE9E-20B1B17E5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47652C-7236-6D36-6CE4-CCCD779B8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E2702A-FCB6-7F88-E048-3905FDB6F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487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681AE5-BB0E-B1E8-C894-925516FA66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429BA8-AD29-FCE2-6F51-23DFF452BA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40A131-CF54-3818-E9C0-61A29329E2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C3F8E6B-49AE-698E-EBC7-F5E9415DC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77455F3-A4A5-39AB-971B-B2964F62D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E1A958C-4EEA-FDAC-11ED-15BE6996F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716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5AA44B-70AE-6BB3-EE5B-69F8832C70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14BC7A-A6BB-834B-2BB1-A8308921C1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564061F-CE60-175E-36D7-AE9CF0B0B1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3B14287-5A5B-4799-2643-62425CF920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37E8BF3-A5F7-8245-CB48-F0EF8EF348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DE23562-8E33-486B-0D43-7847C2F55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96DD8E0-C869-CD12-C7DA-B442B1A2B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4DB1BFA-4F4A-9A17-58B3-3ABF5F9AF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016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7592FE-DF9D-02B4-493D-3D11D1736C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0990A2B-583F-8C23-AD64-6C37AB4C4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921E32A-F65B-86C3-A622-DCA08413B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5F8A93D-FB1D-6DA4-697F-84CF421C7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3743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101434B-BB82-15F2-1CDF-C8BCA54C8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3B44009-C2EA-B69C-8D56-A11B9F6BD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1B0E8D9-3EB7-7C22-D483-32C773133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926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DB301A-DCA1-A1D2-649F-0D8F1FEE8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96782A4-AEC2-CB0E-3D0F-2AFFEF1FE0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E8D7196-357E-1521-47B0-E85F231384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9F45E43-35A9-8880-AF1E-5998403BE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A4B14F6-1C74-636E-84D8-2F81D577B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9278298-425C-467E-AFB1-9396D1C03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044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FB5A32-E57A-2DD2-AE04-073D8660E8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2B12155-2BEE-DD6F-4144-48E0563318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0B92B1-7292-4A17-EB11-9D2B1E6A18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00C92A3-40A0-57FB-3ACA-CF766A114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7E4AC3-EF57-C776-D45A-A111BF565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C750C96-F810-ED0D-2787-A0DCFC312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301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D030642-191B-B8E6-73CD-80428F44DD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E8F7035-E6EA-E3BB-04E8-1F6548673D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9E025A-62AD-FD08-6E2D-1445501E0B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097D9-3804-49CC-B1E3-B726ADF6903D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9B6A46-37A3-E69D-D89C-94028814E1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33797E-BEEC-0F70-3D09-8FCF7555BE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AB509-6BC6-4488-8156-1C2708CBF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456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44C79BE-EF4B-5518-062E-AD3EEC0E4B3F}"/>
              </a:ext>
            </a:extLst>
          </p:cNvPr>
          <p:cNvSpPr/>
          <p:nvPr/>
        </p:nvSpPr>
        <p:spPr>
          <a:xfrm>
            <a:off x="3801136" y="1341912"/>
            <a:ext cx="2019574" cy="38588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=</a:t>
            </a:r>
            <a:r>
              <a:rPr lang="en-US" altLang="ja-JP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45</a:t>
            </a: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09AB22B6-13E7-A884-B986-D8B47F2723A0}"/>
              </a:ext>
            </a:extLst>
          </p:cNvPr>
          <p:cNvCxnSpPr>
            <a:cxnSpLocks/>
            <a:stCxn id="2" idx="2"/>
          </p:cNvCxnSpPr>
          <p:nvPr/>
        </p:nvCxnSpPr>
        <p:spPr>
          <a:xfrm>
            <a:off x="4810923" y="1727793"/>
            <a:ext cx="0" cy="405631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E10B26B9-EABE-8BF6-B374-1BC8CBBDD896}"/>
              </a:ext>
            </a:extLst>
          </p:cNvPr>
          <p:cNvCxnSpPr>
            <a:cxnSpLocks/>
          </p:cNvCxnSpPr>
          <p:nvPr/>
        </p:nvCxnSpPr>
        <p:spPr>
          <a:xfrm>
            <a:off x="4814591" y="3034287"/>
            <a:ext cx="187703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E19AF9D-6B1A-7683-4D9D-47E5938061F2}"/>
              </a:ext>
            </a:extLst>
          </p:cNvPr>
          <p:cNvSpPr txBox="1"/>
          <p:nvPr/>
        </p:nvSpPr>
        <p:spPr>
          <a:xfrm>
            <a:off x="5119387" y="2665400"/>
            <a:ext cx="2019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C474D54-BE53-0026-B05D-4E3AC49FE1D3}"/>
              </a:ext>
            </a:extLst>
          </p:cNvPr>
          <p:cNvSpPr/>
          <p:nvPr/>
        </p:nvSpPr>
        <p:spPr>
          <a:xfrm>
            <a:off x="6692726" y="2674732"/>
            <a:ext cx="2027248" cy="73399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UC at pathology</a:t>
            </a:r>
            <a:r>
              <a:rPr kumimoji="1"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n=2)</a:t>
            </a:r>
            <a:endParaRPr kumimoji="1" lang="ja-JP" altLang="en-US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A461E498-D9C9-FF11-166A-A48382D2FB2F}"/>
              </a:ext>
            </a:extLst>
          </p:cNvPr>
          <p:cNvCxnSpPr>
            <a:cxnSpLocks/>
          </p:cNvCxnSpPr>
          <p:nvPr/>
        </p:nvCxnSpPr>
        <p:spPr>
          <a:xfrm>
            <a:off x="4809902" y="2229614"/>
            <a:ext cx="187703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F5ADBAD-847A-65FB-4494-183D9EE159C4}"/>
              </a:ext>
            </a:extLst>
          </p:cNvPr>
          <p:cNvSpPr/>
          <p:nvPr/>
        </p:nvSpPr>
        <p:spPr>
          <a:xfrm>
            <a:off x="6686939" y="1928466"/>
            <a:ext cx="2027248" cy="5330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rt follow-up period (n=126)</a:t>
            </a:r>
            <a:endParaRPr kumimoji="1" lang="en-US" altLang="ja-JP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E498A1A-76F5-B90C-C371-4483F7E48BEF}"/>
              </a:ext>
            </a:extLst>
          </p:cNvPr>
          <p:cNvSpPr txBox="1"/>
          <p:nvPr/>
        </p:nvSpPr>
        <p:spPr>
          <a:xfrm>
            <a:off x="5114698" y="1860727"/>
            <a:ext cx="2019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6A9887E-6D52-7039-0F8C-F3F985340D5A}"/>
              </a:ext>
            </a:extLst>
          </p:cNvPr>
          <p:cNvSpPr txBox="1"/>
          <p:nvPr/>
        </p:nvSpPr>
        <p:spPr>
          <a:xfrm>
            <a:off x="4265437" y="5833344"/>
            <a:ext cx="102464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n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04</a:t>
            </a:r>
          </a:p>
          <a:p>
            <a:pPr algn="ctr"/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7C5ADB83-2685-1978-D69D-A17127F8BB84}"/>
              </a:ext>
            </a:extLst>
          </p:cNvPr>
          <p:cNvCxnSpPr>
            <a:cxnSpLocks/>
          </p:cNvCxnSpPr>
          <p:nvPr/>
        </p:nvCxnSpPr>
        <p:spPr>
          <a:xfrm>
            <a:off x="4809902" y="5302640"/>
            <a:ext cx="187703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8A7A7C6-0617-51AD-EE0A-2B57DBD5D6F2}"/>
              </a:ext>
            </a:extLst>
          </p:cNvPr>
          <p:cNvSpPr txBox="1"/>
          <p:nvPr/>
        </p:nvSpPr>
        <p:spPr>
          <a:xfrm>
            <a:off x="5114698" y="4933753"/>
            <a:ext cx="2019573" cy="343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7970B065-5F2A-7E3C-E3A2-933BA0189583}"/>
              </a:ext>
            </a:extLst>
          </p:cNvPr>
          <p:cNvSpPr/>
          <p:nvPr/>
        </p:nvSpPr>
        <p:spPr>
          <a:xfrm>
            <a:off x="6688037" y="5072292"/>
            <a:ext cx="2036308" cy="37594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cking data n=1</a:t>
            </a:r>
            <a:endParaRPr kumimoji="1" lang="ja-JP" altLang="en-US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67D8F211-65F6-C0B1-A8BB-0F9BFA47237D}"/>
              </a:ext>
            </a:extLst>
          </p:cNvPr>
          <p:cNvCxnSpPr>
            <a:cxnSpLocks/>
          </p:cNvCxnSpPr>
          <p:nvPr/>
        </p:nvCxnSpPr>
        <p:spPr>
          <a:xfrm>
            <a:off x="4798647" y="3896733"/>
            <a:ext cx="187703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98C5DAB-D848-F236-3497-11E84F6986F4}"/>
              </a:ext>
            </a:extLst>
          </p:cNvPr>
          <p:cNvSpPr txBox="1"/>
          <p:nvPr/>
        </p:nvSpPr>
        <p:spPr>
          <a:xfrm>
            <a:off x="5103443" y="3527846"/>
            <a:ext cx="2019573" cy="343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6750CCDB-A8E2-92BC-E4F1-E188092B1706}"/>
              </a:ext>
            </a:extLst>
          </p:cNvPr>
          <p:cNvSpPr/>
          <p:nvPr/>
        </p:nvSpPr>
        <p:spPr>
          <a:xfrm>
            <a:off x="6676782" y="3626629"/>
            <a:ext cx="2036308" cy="53333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n-US" altLang="ja-JP" sz="14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stoscopic</a:t>
            </a:r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valuation (n=74)</a:t>
            </a:r>
            <a:endParaRPr kumimoji="1" lang="ja-JP" altLang="en-US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32FD3B41-FB55-0A85-3C95-B29BAC24B739}"/>
              </a:ext>
            </a:extLst>
          </p:cNvPr>
          <p:cNvSpPr/>
          <p:nvPr/>
        </p:nvSpPr>
        <p:spPr>
          <a:xfrm>
            <a:off x="3801136" y="5800485"/>
            <a:ext cx="1953242" cy="41536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ja-JP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CDB5D83B-6D54-1BCF-6CF6-76330E7EFF22}"/>
              </a:ext>
            </a:extLst>
          </p:cNvPr>
          <p:cNvSpPr/>
          <p:nvPr/>
        </p:nvSpPr>
        <p:spPr>
          <a:xfrm>
            <a:off x="6675684" y="4408966"/>
            <a:ext cx="2036308" cy="53333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derwent single dose IVI (n=38)</a:t>
            </a:r>
            <a:endParaRPr kumimoji="1" lang="ja-JP" altLang="en-US" sz="14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A0C36648-E9B9-EE70-B09A-BAC90CC64BA0}"/>
              </a:ext>
            </a:extLst>
          </p:cNvPr>
          <p:cNvCxnSpPr>
            <a:cxnSpLocks/>
          </p:cNvCxnSpPr>
          <p:nvPr/>
        </p:nvCxnSpPr>
        <p:spPr>
          <a:xfrm>
            <a:off x="4787309" y="4672357"/>
            <a:ext cx="187703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24D4458-5301-4A74-3124-65C2DCA54D7C}"/>
              </a:ext>
            </a:extLst>
          </p:cNvPr>
          <p:cNvSpPr txBox="1"/>
          <p:nvPr/>
        </p:nvSpPr>
        <p:spPr>
          <a:xfrm>
            <a:off x="5081472" y="4303470"/>
            <a:ext cx="2019573" cy="343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clude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93BDA37-3369-7086-4638-8F79A20AB5DB}"/>
              </a:ext>
            </a:extLst>
          </p:cNvPr>
          <p:cNvSpPr txBox="1"/>
          <p:nvPr/>
        </p:nvSpPr>
        <p:spPr>
          <a:xfrm>
            <a:off x="246388" y="187949"/>
            <a:ext cx="7579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Th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reasons and numbers for excluded patients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0519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9</TotalTime>
  <Words>63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哲哉 進藤</dc:creator>
  <cp:lastModifiedBy>哲哉 進藤</cp:lastModifiedBy>
  <cp:revision>12</cp:revision>
  <cp:lastPrinted>2024-05-28T02:34:34Z</cp:lastPrinted>
  <dcterms:created xsi:type="dcterms:W3CDTF">2024-05-18T02:41:56Z</dcterms:created>
  <dcterms:modified xsi:type="dcterms:W3CDTF">2024-10-22T08:50:18Z</dcterms:modified>
</cp:coreProperties>
</file>